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6858000" cy="9906000" type="A4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39" autoAdjust="0"/>
    <p:restoredTop sz="94660"/>
  </p:normalViewPr>
  <p:slideViewPr>
    <p:cSldViewPr snapToGrid="0">
      <p:cViewPr varScale="1">
        <p:scale>
          <a:sx n="73" d="100"/>
          <a:sy n="73" d="100"/>
        </p:scale>
        <p:origin x="243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27B088-4977-458E-83CB-9845DCDA4924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1DADD5-FAE0-4D3B-83C0-6FEBD756C033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468135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EBE6CE-D66B-43CE-913C-80D055B2D41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300E2-8266-416D-B540-1E2178BC5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362032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8911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75963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46655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86538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98765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01565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32110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07970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12040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96652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41867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43678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01436" y="818416"/>
            <a:ext cx="1287674" cy="489446"/>
            <a:chOff x="636290" y="1261258"/>
            <a:chExt cx="1287674" cy="489446"/>
          </a:xfrm>
        </p:grpSpPr>
        <p:sp>
          <p:nvSpPr>
            <p:cNvPr id="3" name="Rectangle 2"/>
            <p:cNvSpPr/>
            <p:nvPr/>
          </p:nvSpPr>
          <p:spPr>
            <a:xfrm>
              <a:off x="636290" y="1261258"/>
              <a:ext cx="1278532" cy="4894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58369" y="1328701"/>
              <a:ext cx="12655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Total DNA</a:t>
              </a:r>
              <a:endParaRPr lang="en-US" dirty="0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2201436" y="1844289"/>
            <a:ext cx="1345303" cy="489446"/>
            <a:chOff x="676657" y="2267728"/>
            <a:chExt cx="1345303" cy="489446"/>
          </a:xfrm>
        </p:grpSpPr>
        <p:sp>
          <p:nvSpPr>
            <p:cNvPr id="6" name="TextBox 5"/>
            <p:cNvSpPr txBox="1"/>
            <p:nvPr/>
          </p:nvSpPr>
          <p:spPr>
            <a:xfrm>
              <a:off x="680788" y="2339450"/>
              <a:ext cx="1341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RCA Product</a:t>
              </a:r>
              <a:endParaRPr lang="en-US" dirty="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676657" y="2267728"/>
              <a:ext cx="1345303" cy="4894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2201436" y="2870162"/>
            <a:ext cx="850265" cy="489446"/>
            <a:chOff x="676658" y="3270214"/>
            <a:chExt cx="850265" cy="489446"/>
          </a:xfrm>
        </p:grpSpPr>
        <p:sp>
          <p:nvSpPr>
            <p:cNvPr id="9" name="TextBox 8"/>
            <p:cNvSpPr txBox="1"/>
            <p:nvPr/>
          </p:nvSpPr>
          <p:spPr>
            <a:xfrm>
              <a:off x="678102" y="3339415"/>
              <a:ext cx="8286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Library</a:t>
              </a:r>
              <a:endParaRPr lang="en-US" dirty="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676658" y="3270214"/>
              <a:ext cx="850265" cy="4894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2201436" y="4921907"/>
            <a:ext cx="1173350" cy="489446"/>
            <a:chOff x="658006" y="5364749"/>
            <a:chExt cx="1173350" cy="489446"/>
          </a:xfrm>
        </p:grpSpPr>
        <p:sp>
          <p:nvSpPr>
            <p:cNvPr id="12" name="TextBox 11"/>
            <p:cNvSpPr txBox="1"/>
            <p:nvPr/>
          </p:nvSpPr>
          <p:spPr>
            <a:xfrm>
              <a:off x="673307" y="5425352"/>
              <a:ext cx="11489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 smtClean="0"/>
                <a:t>FastQ</a:t>
              </a:r>
              <a:r>
                <a:rPr lang="en-US" dirty="0" smtClean="0"/>
                <a:t> files</a:t>
              </a:r>
              <a:endParaRPr lang="en-US" dirty="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58006" y="5364749"/>
              <a:ext cx="1173350" cy="4894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2346556" y="1414139"/>
            <a:ext cx="11419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>
                <a:solidFill>
                  <a:srgbClr val="FF0000"/>
                </a:solidFill>
              </a:rPr>
              <a:t>RCA reactio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346556" y="2448297"/>
            <a:ext cx="10029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err="1" smtClean="0">
                <a:solidFill>
                  <a:srgbClr val="FF0000"/>
                </a:solidFill>
              </a:rPr>
              <a:t>Nextera</a:t>
            </a:r>
            <a:r>
              <a:rPr lang="en-US" sz="1400" b="1" i="1" dirty="0" smtClean="0">
                <a:solidFill>
                  <a:srgbClr val="FF0000"/>
                </a:solidFill>
              </a:rPr>
              <a:t> XT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346556" y="4516614"/>
            <a:ext cx="13708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>
                <a:solidFill>
                  <a:srgbClr val="FF0000"/>
                </a:solidFill>
              </a:rPr>
              <a:t>HiSeq Rapid run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749036" y="1296838"/>
            <a:ext cx="139653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30 min hands on</a:t>
            </a:r>
          </a:p>
          <a:p>
            <a:r>
              <a:rPr lang="en-US" sz="1400" dirty="0" smtClean="0"/>
              <a:t>12H reaction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3749036" y="2336504"/>
            <a:ext cx="139653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30 min hands on</a:t>
            </a:r>
          </a:p>
          <a:p>
            <a:r>
              <a:rPr lang="en-US" sz="1400" dirty="0" smtClean="0"/>
              <a:t>1H reaction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3749036" y="3872316"/>
            <a:ext cx="13901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2H hands on</a:t>
            </a:r>
          </a:p>
          <a:p>
            <a:r>
              <a:rPr lang="en-US" sz="1400" dirty="0" smtClean="0"/>
              <a:t>30 H sequencing</a:t>
            </a:r>
            <a:endParaRPr lang="en-US" sz="1400" dirty="0"/>
          </a:p>
        </p:txBody>
      </p:sp>
      <p:grpSp>
        <p:nvGrpSpPr>
          <p:cNvPr id="20" name="Group 19"/>
          <p:cNvGrpSpPr/>
          <p:nvPr/>
        </p:nvGrpSpPr>
        <p:grpSpPr>
          <a:xfrm>
            <a:off x="2201436" y="3896035"/>
            <a:ext cx="1337690" cy="489446"/>
            <a:chOff x="647712" y="4210900"/>
            <a:chExt cx="1337690" cy="489446"/>
          </a:xfrm>
        </p:grpSpPr>
        <p:sp>
          <p:nvSpPr>
            <p:cNvPr id="21" name="TextBox 20"/>
            <p:cNvSpPr txBox="1"/>
            <p:nvPr/>
          </p:nvSpPr>
          <p:spPr>
            <a:xfrm>
              <a:off x="658302" y="4270957"/>
              <a:ext cx="13271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Library Pool</a:t>
              </a:r>
              <a:endParaRPr lang="en-US" dirty="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647712" y="4210900"/>
              <a:ext cx="1337690" cy="4894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2346556" y="3482455"/>
            <a:ext cx="74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>
                <a:solidFill>
                  <a:srgbClr val="FF0000"/>
                </a:solidFill>
              </a:rPr>
              <a:t>Pooling</a:t>
            </a: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2320722" y="1397513"/>
            <a:ext cx="0" cy="39609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2320722" y="2421993"/>
            <a:ext cx="0" cy="39609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2323442" y="3446473"/>
            <a:ext cx="0" cy="39609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2320367" y="4470953"/>
            <a:ext cx="0" cy="39609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3739892" y="1232830"/>
            <a:ext cx="0" cy="6701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3739892" y="2313152"/>
            <a:ext cx="0" cy="59877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3739892" y="3324404"/>
            <a:ext cx="0" cy="161579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4029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9</TotalTime>
  <Words>35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estl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quis,Julien,LAUSANNE,Functional Genomics</dc:creator>
  <cp:lastModifiedBy>Marquis,Julien,LAUSANNE,Functional Genomics</cp:lastModifiedBy>
  <cp:revision>37</cp:revision>
  <cp:lastPrinted>2016-01-06T12:41:26Z</cp:lastPrinted>
  <dcterms:created xsi:type="dcterms:W3CDTF">2016-01-06T07:21:02Z</dcterms:created>
  <dcterms:modified xsi:type="dcterms:W3CDTF">2016-03-11T16:42:35Z</dcterms:modified>
</cp:coreProperties>
</file>